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xlsx" ContentType="application/vnd.openxmlformats-officedocument.spreadsheetml.sheet"/>
  <Override PartName="/ppt/embeddings/oleObject2.xlsx" ContentType="application/vnd.openxmlformats-officedocument.spreadsheetml.sheet"/>
  <Override PartName="/ppt/embeddings/oleObject3.xlsx" ContentType="application/vnd.openxmlformats-officedocument.spreadsheetml.sheet"/>
  <Override PartName="/ppt/media/image1.png" ContentType="image/pn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639197-AC1C-4001-A5F6-3E94FAC79F1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A5A3B1-9D89-4FF5-8AF7-A06733E2982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5FF6A8-74DC-4DC2-87AF-BE75195AF59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0F3088-9263-46C1-A253-61F0091041A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BCA460-1CDF-4BEA-A988-33EFAAD8361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22B88B-6C13-40D8-9CA0-81D5EC5C6C8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257540-F6E1-40C8-BD22-AFAB59B6B34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617BC0-B3D4-4A78-AE76-97D8C8DFA82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AC265C-0E6F-431D-8DCF-F2A4ED844AE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584DA8-652E-45EC-B7E1-687C6CE225F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0B5F5B-4479-4B8C-A31B-37C545AB6C0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B80376-A08F-495B-B8AF-DE428B0D854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02E514E-C381-40E9-9467-928D500B9218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1.png"/><Relationship Id="rId3" Type="http://schemas.openxmlformats.org/officeDocument/2006/relationships/package" Target="../embeddings/oleObject2.xlsx"/><Relationship Id="rId4" Type="http://schemas.openxmlformats.org/officeDocument/2006/relationships/image" Target="../media/image2.png"/><Relationship Id="rId5" Type="http://schemas.openxmlformats.org/officeDocument/2006/relationships/package" Target="../embeddings/oleObject3.xlsx"/><Relationship Id="rId6" Type="http://schemas.openxmlformats.org/officeDocument/2006/relationships/image" Target="../media/image3.png"/><Relationship Id="rId7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304920" y="3672000"/>
          <a:ext cx="2819160" cy="2423880"/>
        </p:xfrm>
        <a:graphic>
          <a:graphicData uri="http://schemas.openxmlformats.org/drawingml/2006/table">
            <a:tbl>
              <a:tblPr/>
              <a:tblGrid>
                <a:gridCol w="479160"/>
                <a:gridCol w="479160"/>
                <a:gridCol w="481320"/>
                <a:gridCol w="479160"/>
                <a:gridCol w="420840"/>
                <a:gridCol w="479520"/>
              </a:tblGrid>
              <a:tr h="15120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804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●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●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●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○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○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●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15804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○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○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○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○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○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○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5804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●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●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●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●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○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●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5804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○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●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●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○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○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●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5804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○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○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○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○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○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○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5804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○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○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○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○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○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○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5804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○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○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○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○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○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○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5804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●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○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●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○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○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●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5804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●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●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●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●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○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●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5804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○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○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○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○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○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○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5804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○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○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○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○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○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●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5804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○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○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○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○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○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●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844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5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5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5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5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5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5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26568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5.0%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5.0%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1.6%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6.0%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%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8.3%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2" name=""/>
          <p:cNvSpPr/>
          <p:nvPr/>
        </p:nvSpPr>
        <p:spPr>
          <a:xfrm>
            <a:off x="1344240" y="3427560"/>
            <a:ext cx="772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CpG site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 rot="16200000">
            <a:off x="-218520" y="4552560"/>
            <a:ext cx="7444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lone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189000" y="5738760"/>
            <a:ext cx="3067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% of methylation obtained through cloning and sequencin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5" name=""/>
          <p:cNvGrpSpPr/>
          <p:nvPr/>
        </p:nvGrpSpPr>
        <p:grpSpPr>
          <a:xfrm>
            <a:off x="3363840" y="3530520"/>
            <a:ext cx="3436920" cy="2497320"/>
            <a:chOff x="3363840" y="3530520"/>
            <a:chExt cx="3436920" cy="2497320"/>
          </a:xfrm>
        </p:grpSpPr>
        <p:graphicFrame>
          <p:nvGraphicFramePr>
            <p:cNvPr id="46" name=""/>
            <p:cNvGraphicFramePr/>
            <p:nvPr/>
          </p:nvGraphicFramePr>
          <p:xfrm>
            <a:off x="3619440" y="3530520"/>
            <a:ext cx="3181320" cy="2360520"/>
          </p:xfrm>
          <a:graphic>
            <a:graphicData uri="http://schemas.openxmlformats.org/presentationml/2006/ole">
              <p:oleObj progId="Excel.Sheet.12" r:id="rId1" spid="">
                <p:embed/>
                <p:pic>
                  <p:nvPicPr>
                    <p:cNvPr id="47" name="" descr=""/>
                    <p:cNvPicPr/>
                    <p:nvPr/>
                  </p:nvPicPr>
                  <p:blipFill>
                    <a:blip r:embed="rId2"/>
                    <a:stretch/>
                  </p:blipFill>
                  <p:spPr>
                    <a:xfrm>
                      <a:off x="3619440" y="3530520"/>
                      <a:ext cx="3181320" cy="236052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48" name=""/>
            <p:cNvSpPr/>
            <p:nvPr/>
          </p:nvSpPr>
          <p:spPr>
            <a:xfrm>
              <a:off x="4013280" y="3728880"/>
              <a:ext cx="1904760" cy="3812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4390920" y="3683160"/>
              <a:ext cx="1651320" cy="450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3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Cloning and sequencing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3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Direct sequencing (raw data)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50" name=""/>
            <p:cNvGrpSpPr/>
            <p:nvPr/>
          </p:nvGrpSpPr>
          <p:grpSpPr>
            <a:xfrm>
              <a:off x="4102200" y="3792600"/>
              <a:ext cx="304560" cy="75960"/>
              <a:chOff x="4102200" y="3792600"/>
              <a:chExt cx="304560" cy="75960"/>
            </a:xfrm>
          </p:grpSpPr>
          <p:sp>
            <p:nvSpPr>
              <p:cNvPr id="51" name=""/>
              <p:cNvSpPr/>
              <p:nvPr/>
            </p:nvSpPr>
            <p:spPr>
              <a:xfrm>
                <a:off x="4102200" y="3830400"/>
                <a:ext cx="3045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prstDash val="dash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" name=""/>
              <p:cNvSpPr/>
              <p:nvPr/>
            </p:nvSpPr>
            <p:spPr>
              <a:xfrm>
                <a:off x="4228920" y="3792600"/>
                <a:ext cx="75960" cy="7596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6840" bIns="68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53" name=""/>
            <p:cNvGrpSpPr/>
            <p:nvPr/>
          </p:nvGrpSpPr>
          <p:grpSpPr>
            <a:xfrm>
              <a:off x="4102200" y="3970440"/>
              <a:ext cx="304560" cy="75960"/>
              <a:chOff x="4102200" y="3970440"/>
              <a:chExt cx="304560" cy="75960"/>
            </a:xfrm>
          </p:grpSpPr>
          <p:sp>
            <p:nvSpPr>
              <p:cNvPr id="54" name=""/>
              <p:cNvSpPr/>
              <p:nvPr/>
            </p:nvSpPr>
            <p:spPr>
              <a:xfrm>
                <a:off x="4102200" y="4008240"/>
                <a:ext cx="3045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" name=""/>
              <p:cNvSpPr/>
              <p:nvPr/>
            </p:nvSpPr>
            <p:spPr>
              <a:xfrm>
                <a:off x="4216320" y="3970440"/>
                <a:ext cx="75960" cy="7596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29160" bIns="291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56" name=""/>
            <p:cNvSpPr/>
            <p:nvPr/>
          </p:nvSpPr>
          <p:spPr>
            <a:xfrm>
              <a:off x="4973040" y="5781600"/>
              <a:ext cx="7722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CpG site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 rot="16200000">
              <a:off x="2593080" y="4446000"/>
              <a:ext cx="1817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percent of methylatio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8" name=""/>
          <p:cNvGrpSpPr/>
          <p:nvPr/>
        </p:nvGrpSpPr>
        <p:grpSpPr>
          <a:xfrm>
            <a:off x="3335400" y="6546960"/>
            <a:ext cx="3446280" cy="2497320"/>
            <a:chOff x="3335400" y="6546960"/>
            <a:chExt cx="3446280" cy="2497320"/>
          </a:xfrm>
        </p:grpSpPr>
        <p:grpSp>
          <p:nvGrpSpPr>
            <p:cNvPr id="59" name=""/>
            <p:cNvGrpSpPr/>
            <p:nvPr/>
          </p:nvGrpSpPr>
          <p:grpSpPr>
            <a:xfrm>
              <a:off x="3583080" y="6546960"/>
              <a:ext cx="3198600" cy="2303280"/>
              <a:chOff x="3583080" y="6546960"/>
              <a:chExt cx="3198600" cy="2303280"/>
            </a:xfrm>
          </p:grpSpPr>
          <p:graphicFrame>
            <p:nvGraphicFramePr>
              <p:cNvPr id="60" name=""/>
              <p:cNvGraphicFramePr/>
              <p:nvPr/>
            </p:nvGraphicFramePr>
            <p:xfrm>
              <a:off x="3583080" y="6546960"/>
              <a:ext cx="3198600" cy="2303280"/>
            </p:xfrm>
            <a:graphic>
              <a:graphicData uri="http://schemas.openxmlformats.org/presentationml/2006/ole">
                <p:oleObj progId="Excel.Sheet.12" r:id="rId3" spid="">
                  <p:embed/>
                  <p:pic>
                    <p:nvPicPr>
                      <p:cNvPr id="61" name="" descr=""/>
                      <p:cNvPicPr/>
                      <p:nvPr/>
                    </p:nvPicPr>
                    <p:blipFill>
                      <a:blip r:embed="rId4"/>
                      <a:stretch/>
                    </p:blipFill>
                    <p:spPr>
                      <a:xfrm>
                        <a:off x="3583080" y="6546960"/>
                        <a:ext cx="3198600" cy="230328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</p:oleObj>
              </a:graphicData>
            </a:graphic>
          </p:graphicFrame>
          <p:sp>
            <p:nvSpPr>
              <p:cNvPr id="62" name=""/>
              <p:cNvSpPr/>
              <p:nvPr/>
            </p:nvSpPr>
            <p:spPr>
              <a:xfrm>
                <a:off x="4027320" y="6744960"/>
                <a:ext cx="1904400" cy="38088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" name=""/>
              <p:cNvSpPr/>
              <p:nvPr/>
            </p:nvSpPr>
            <p:spPr>
              <a:xfrm>
                <a:off x="4404600" y="6698880"/>
                <a:ext cx="1651320" cy="450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3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Cloning and sequencing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Direct sequencing (raw data)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64" name=""/>
              <p:cNvGrpSpPr/>
              <p:nvPr/>
            </p:nvGrpSpPr>
            <p:grpSpPr>
              <a:xfrm>
                <a:off x="4116240" y="6808680"/>
                <a:ext cx="304200" cy="75600"/>
                <a:chOff x="4116240" y="6808680"/>
                <a:chExt cx="304200" cy="75600"/>
              </a:xfrm>
            </p:grpSpPr>
            <p:sp>
              <p:nvSpPr>
                <p:cNvPr id="65" name=""/>
                <p:cNvSpPr/>
                <p:nvPr/>
              </p:nvSpPr>
              <p:spPr>
                <a:xfrm>
                  <a:off x="4116240" y="6846480"/>
                  <a:ext cx="30420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prstDash val="dash"/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6" name=""/>
                <p:cNvSpPr/>
                <p:nvPr/>
              </p:nvSpPr>
              <p:spPr>
                <a:xfrm>
                  <a:off x="4242960" y="6808680"/>
                  <a:ext cx="75960" cy="75600"/>
                </a:xfrm>
                <a:prstGeom prst="ellipse">
                  <a:avLst/>
                </a:prstGeom>
                <a:solidFill>
                  <a:srgbClr val="00000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7200" bIns="72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67" name=""/>
              <p:cNvGrpSpPr/>
              <p:nvPr/>
            </p:nvGrpSpPr>
            <p:grpSpPr>
              <a:xfrm>
                <a:off x="4116240" y="6986160"/>
                <a:ext cx="304200" cy="75960"/>
                <a:chOff x="4116240" y="6986160"/>
                <a:chExt cx="304200" cy="75960"/>
              </a:xfrm>
            </p:grpSpPr>
            <p:sp>
              <p:nvSpPr>
                <p:cNvPr id="68" name=""/>
                <p:cNvSpPr/>
                <p:nvPr/>
              </p:nvSpPr>
              <p:spPr>
                <a:xfrm>
                  <a:off x="4116240" y="7023960"/>
                  <a:ext cx="30420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9" name=""/>
                <p:cNvSpPr/>
                <p:nvPr/>
              </p:nvSpPr>
              <p:spPr>
                <a:xfrm>
                  <a:off x="4230360" y="6986160"/>
                  <a:ext cx="75960" cy="75960"/>
                </a:xfrm>
                <a:prstGeom prst="rect">
                  <a:avLst/>
                </a:prstGeom>
                <a:solidFill>
                  <a:srgbClr val="00000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29160" bIns="2916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sp>
          <p:nvSpPr>
            <p:cNvPr id="70" name=""/>
            <p:cNvSpPr/>
            <p:nvPr/>
          </p:nvSpPr>
          <p:spPr>
            <a:xfrm>
              <a:off x="5000040" y="8798040"/>
              <a:ext cx="7722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CpG site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"/>
            <p:cNvSpPr/>
            <p:nvPr/>
          </p:nvSpPr>
          <p:spPr>
            <a:xfrm rot="16200000">
              <a:off x="2564640" y="7480080"/>
              <a:ext cx="1817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percent of methylatio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aphicFrame>
        <p:nvGraphicFramePr>
          <p:cNvPr id="72" name=""/>
          <p:cNvGraphicFramePr/>
          <p:nvPr/>
        </p:nvGraphicFramePr>
        <p:xfrm>
          <a:off x="228600" y="6904080"/>
          <a:ext cx="2895480" cy="2036880"/>
        </p:xfrm>
        <a:graphic>
          <a:graphicData uri="http://schemas.openxmlformats.org/drawingml/2006/table">
            <a:tbl>
              <a:tblPr/>
              <a:tblGrid>
                <a:gridCol w="503280"/>
                <a:gridCol w="503280"/>
                <a:gridCol w="503280"/>
                <a:gridCol w="441360"/>
                <a:gridCol w="441000"/>
                <a:gridCol w="503280"/>
              </a:tblGrid>
              <a:tr h="15480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789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●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○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○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○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○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○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1789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○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○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○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○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○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○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7748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○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○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●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○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○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○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7928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○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○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●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○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○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○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7748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●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●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●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○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○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●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789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○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●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●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○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○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●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789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○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○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○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○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○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○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7748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●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○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○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○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○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○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0204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5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5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5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5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5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5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5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15480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7.5%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5.0%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0.0%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%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%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5.0%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73" name=""/>
          <p:cNvSpPr/>
          <p:nvPr/>
        </p:nvSpPr>
        <p:spPr>
          <a:xfrm rot="16200000">
            <a:off x="-256680" y="7597080"/>
            <a:ext cx="7444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lone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147600" y="8570880"/>
            <a:ext cx="3067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% of methylation obtained through cloning and sequencin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1325160" y="6659640"/>
            <a:ext cx="772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CpG site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>
            <a:off x="314280" y="6337440"/>
            <a:ext cx="10083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c) Animal 23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>
            <a:off x="303480" y="3174840"/>
            <a:ext cx="9381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b) Animal 2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78" name=""/>
          <p:cNvGraphicFramePr/>
          <p:nvPr/>
        </p:nvGraphicFramePr>
        <p:xfrm>
          <a:off x="228600" y="923760"/>
          <a:ext cx="2895480" cy="1971360"/>
        </p:xfrm>
        <a:graphic>
          <a:graphicData uri="http://schemas.openxmlformats.org/drawingml/2006/table">
            <a:tbl>
              <a:tblPr/>
              <a:tblGrid>
                <a:gridCol w="482400"/>
                <a:gridCol w="482400"/>
                <a:gridCol w="482760"/>
                <a:gridCol w="482400"/>
                <a:gridCol w="482760"/>
                <a:gridCol w="482760"/>
              </a:tblGrid>
              <a:tr h="15480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6236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○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●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○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○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○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○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16236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○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○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○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○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○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○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236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○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○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●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○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○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●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236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○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●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●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○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○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●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236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●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○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○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●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●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●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236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●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○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○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●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●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●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236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●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●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●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●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●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●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236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○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●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●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○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○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●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236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○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○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●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○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○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○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0204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5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5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5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5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5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5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5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15480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3.3%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4.4%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5.6%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3.3%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3.3%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lnSpc>
                          <a:spcPct val="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6.7%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79" name=""/>
          <p:cNvSpPr/>
          <p:nvPr/>
        </p:nvSpPr>
        <p:spPr>
          <a:xfrm>
            <a:off x="147600" y="2529000"/>
            <a:ext cx="3067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% of methylation obtained through cloning and sequencin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>
            <a:off x="1315440" y="676440"/>
            <a:ext cx="772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CpG site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 rot="16200000">
            <a:off x="-237600" y="1609200"/>
            <a:ext cx="7444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lone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82" name=""/>
          <p:cNvGrpSpPr/>
          <p:nvPr/>
        </p:nvGrpSpPr>
        <p:grpSpPr>
          <a:xfrm>
            <a:off x="3352680" y="628560"/>
            <a:ext cx="3505320" cy="2421360"/>
            <a:chOff x="3352680" y="628560"/>
            <a:chExt cx="3505320" cy="2421360"/>
          </a:xfrm>
        </p:grpSpPr>
        <p:grpSp>
          <p:nvGrpSpPr>
            <p:cNvPr id="83" name=""/>
            <p:cNvGrpSpPr/>
            <p:nvPr/>
          </p:nvGrpSpPr>
          <p:grpSpPr>
            <a:xfrm>
              <a:off x="3521160" y="628560"/>
              <a:ext cx="3336840" cy="2203200"/>
              <a:chOff x="3521160" y="628560"/>
              <a:chExt cx="3336840" cy="2203200"/>
            </a:xfrm>
          </p:grpSpPr>
          <p:graphicFrame>
            <p:nvGraphicFramePr>
              <p:cNvPr id="84" name=""/>
              <p:cNvGraphicFramePr/>
              <p:nvPr/>
            </p:nvGraphicFramePr>
            <p:xfrm>
              <a:off x="3521160" y="628560"/>
              <a:ext cx="3336840" cy="2203200"/>
            </p:xfrm>
            <a:graphic>
              <a:graphicData uri="http://schemas.openxmlformats.org/presentationml/2006/ole">
                <p:oleObj progId="Excel.Sheet.12" r:id="rId5" spid="">
                  <p:embed/>
                  <p:pic>
                    <p:nvPicPr>
                      <p:cNvPr id="85" name="" descr=""/>
                      <p:cNvPicPr/>
                      <p:nvPr/>
                    </p:nvPicPr>
                    <p:blipFill>
                      <a:blip r:embed="rId6"/>
                      <a:stretch/>
                    </p:blipFill>
                    <p:spPr>
                      <a:xfrm>
                        <a:off x="3521160" y="628560"/>
                        <a:ext cx="3336840" cy="220320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</p:oleObj>
              </a:graphicData>
            </a:graphic>
          </p:graphicFrame>
          <p:sp>
            <p:nvSpPr>
              <p:cNvPr id="86" name=""/>
              <p:cNvSpPr/>
              <p:nvPr/>
            </p:nvSpPr>
            <p:spPr>
              <a:xfrm>
                <a:off x="4041720" y="750600"/>
                <a:ext cx="1904400" cy="38124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" name=""/>
              <p:cNvSpPr/>
              <p:nvPr/>
            </p:nvSpPr>
            <p:spPr>
              <a:xfrm>
                <a:off x="4419000" y="704520"/>
                <a:ext cx="1651320" cy="450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3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Cloning and sequencing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Direct sequencing (raw data)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88" name=""/>
              <p:cNvGrpSpPr/>
              <p:nvPr/>
            </p:nvGrpSpPr>
            <p:grpSpPr>
              <a:xfrm>
                <a:off x="4130640" y="814320"/>
                <a:ext cx="304200" cy="75960"/>
                <a:chOff x="4130640" y="814320"/>
                <a:chExt cx="304200" cy="75960"/>
              </a:xfrm>
            </p:grpSpPr>
            <p:sp>
              <p:nvSpPr>
                <p:cNvPr id="89" name=""/>
                <p:cNvSpPr/>
                <p:nvPr/>
              </p:nvSpPr>
              <p:spPr>
                <a:xfrm>
                  <a:off x="4130640" y="852120"/>
                  <a:ext cx="30420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prstDash val="dash"/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0" name=""/>
                <p:cNvSpPr/>
                <p:nvPr/>
              </p:nvSpPr>
              <p:spPr>
                <a:xfrm>
                  <a:off x="4257360" y="814320"/>
                  <a:ext cx="75960" cy="75960"/>
                </a:xfrm>
                <a:prstGeom prst="ellipse">
                  <a:avLst/>
                </a:prstGeom>
                <a:solidFill>
                  <a:srgbClr val="00000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6840" bIns="684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91" name=""/>
              <p:cNvGrpSpPr/>
              <p:nvPr/>
            </p:nvGrpSpPr>
            <p:grpSpPr>
              <a:xfrm>
                <a:off x="4130640" y="991800"/>
                <a:ext cx="304200" cy="76320"/>
                <a:chOff x="4130640" y="991800"/>
                <a:chExt cx="304200" cy="76320"/>
              </a:xfrm>
            </p:grpSpPr>
            <p:sp>
              <p:nvSpPr>
                <p:cNvPr id="92" name=""/>
                <p:cNvSpPr/>
                <p:nvPr/>
              </p:nvSpPr>
              <p:spPr>
                <a:xfrm>
                  <a:off x="4130640" y="1029960"/>
                  <a:ext cx="30420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3" name=""/>
                <p:cNvSpPr/>
                <p:nvPr/>
              </p:nvSpPr>
              <p:spPr>
                <a:xfrm>
                  <a:off x="4244760" y="991800"/>
                  <a:ext cx="75960" cy="76320"/>
                </a:xfrm>
                <a:prstGeom prst="rect">
                  <a:avLst/>
                </a:prstGeom>
                <a:solidFill>
                  <a:srgbClr val="00000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29520" bIns="2952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sp>
          <p:nvSpPr>
            <p:cNvPr id="94" name=""/>
            <p:cNvSpPr/>
            <p:nvPr/>
          </p:nvSpPr>
          <p:spPr>
            <a:xfrm>
              <a:off x="4979520" y="2803680"/>
              <a:ext cx="7722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CpG site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"/>
            <p:cNvSpPr/>
            <p:nvPr/>
          </p:nvSpPr>
          <p:spPr>
            <a:xfrm rot="16200000">
              <a:off x="2581920" y="1485720"/>
              <a:ext cx="1817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percent of methylatio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96" name=""/>
          <p:cNvSpPr/>
          <p:nvPr/>
        </p:nvSpPr>
        <p:spPr>
          <a:xfrm>
            <a:off x="302400" y="347760"/>
            <a:ext cx="9702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a) Animal 1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4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6-02T18:47:51Z</dcterms:created>
  <dc:creator>Carlos</dc:creator>
  <dc:description/>
  <dc:language>en-US</dc:language>
  <cp:lastModifiedBy>Dane.Brookes</cp:lastModifiedBy>
  <dcterms:modified xsi:type="dcterms:W3CDTF">2008-08-29T14:41:17Z</dcterms:modified>
  <cp:revision>19</cp:revision>
  <dc:subject/>
  <dc:title>Slide 1</dc:title>
</cp:coreProperties>
</file>